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2216" y="-8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87240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76663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227432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545265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8566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22639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44737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75331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74458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763737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07772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738127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/>
          <p:nvPr/>
        </p:nvPicPr>
        <p:blipFill>
          <a:blip r:embed="rId2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915897" y="796852"/>
            <a:ext cx="5349240" cy="562356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/>
          <p:cNvSpPr/>
          <p:nvPr/>
        </p:nvSpPr>
        <p:spPr>
          <a:xfrm>
            <a:off x="541107" y="6588224"/>
            <a:ext cx="596297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Supplemental Fig. S8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opology of referenc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ynthase protein sequences and putative proteins derived from EST sequences from jack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odgepol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pine with high BLAST hits to similar genes/proteins. Sequences pointed with arrows were investigat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PCR. Relationships were estimated using th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eighbou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joining method and the consensus tree was inferred from 1000 bootstrap replicates with bootstrap values shown next to their branches. Ag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Abie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grandi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inu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banksian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Pc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inu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contort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g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ice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gluac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Pm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seudotsug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menziesii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Ps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ice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sitchensi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inu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taed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1057678" y="842394"/>
            <a:ext cx="994362" cy="40633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>
                <a:effectLst/>
                <a:latin typeface="Times New Roman"/>
                <a:ea typeface="Calibri"/>
                <a:cs typeface="Times New Roman"/>
              </a:rPr>
              <a:t>Diterpene synthases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0" y="4861004"/>
            <a:ext cx="1154910" cy="51706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 err="1">
                <a:effectLst/>
                <a:latin typeface="Times New Roman"/>
                <a:ea typeface="Calibri"/>
                <a:cs typeface="Times New Roman"/>
              </a:rPr>
              <a:t>Sesquiterpene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 synthases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7" name="Text Box 2"/>
          <p:cNvSpPr txBox="1">
            <a:spLocks noChangeArrowheads="1"/>
          </p:cNvSpPr>
          <p:nvPr/>
        </p:nvSpPr>
        <p:spPr bwMode="auto">
          <a:xfrm>
            <a:off x="5674426" y="1184403"/>
            <a:ext cx="1183574" cy="51706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 err="1">
                <a:effectLst/>
                <a:latin typeface="Times New Roman"/>
                <a:ea typeface="Calibri"/>
                <a:cs typeface="Times New Roman"/>
              </a:rPr>
              <a:t>Monoterpene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 synthases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8" name="Donut 7"/>
          <p:cNvSpPr/>
          <p:nvPr/>
        </p:nvSpPr>
        <p:spPr>
          <a:xfrm>
            <a:off x="726402" y="671389"/>
            <a:ext cx="5803309" cy="5752148"/>
          </a:xfrm>
          <a:prstGeom prst="donut">
            <a:avLst>
              <a:gd name="adj" fmla="val 30133"/>
            </a:avLst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CA"/>
          </a:p>
        </p:txBody>
      </p:sp>
      <p:cxnSp>
        <p:nvCxnSpPr>
          <p:cNvPr id="9" name="Straight Connector 8"/>
          <p:cNvCxnSpPr/>
          <p:nvPr/>
        </p:nvCxnSpPr>
        <p:spPr>
          <a:xfrm flipH="1" flipV="1">
            <a:off x="3120355" y="724827"/>
            <a:ext cx="359457" cy="1672288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 flipV="1">
            <a:off x="1057708" y="2231806"/>
            <a:ext cx="1518704" cy="827781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2511180" y="4615185"/>
            <a:ext cx="695484" cy="1591255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1057708" y="2744821"/>
            <a:ext cx="271719" cy="104099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2821111" y="1259218"/>
            <a:ext cx="92892" cy="27276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 flipV="1">
            <a:off x="5044067" y="5224389"/>
            <a:ext cx="190506" cy="21458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V="1">
            <a:off x="3045544" y="5854968"/>
            <a:ext cx="59251" cy="263346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70469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114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ba</dc:creator>
  <cp:lastModifiedBy>Adriana</cp:lastModifiedBy>
  <cp:revision>22</cp:revision>
  <dcterms:created xsi:type="dcterms:W3CDTF">2013-07-09T00:37:10Z</dcterms:created>
  <dcterms:modified xsi:type="dcterms:W3CDTF">2013-07-09T00:39:45Z</dcterms:modified>
</cp:coreProperties>
</file>